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14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779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75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954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696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461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58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2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38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628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526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D618A-BC7A-4461-82B7-D784B0E8A53D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D2890-7B62-43CD-94AB-B7D5C7520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469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838200"/>
            <a:ext cx="6935787" cy="301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28601" y="4343400"/>
            <a:ext cx="85343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umulation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ongation fact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vElf1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leaf and root tissues under drought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t stresses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rietie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2452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sakh, Niranjan</dc:creator>
  <cp:lastModifiedBy>Baisakh, Niranjan</cp:lastModifiedBy>
  <cp:revision>1</cp:revision>
  <dcterms:created xsi:type="dcterms:W3CDTF">2015-07-17T02:50:37Z</dcterms:created>
  <dcterms:modified xsi:type="dcterms:W3CDTF">2015-07-17T02:50:57Z</dcterms:modified>
</cp:coreProperties>
</file>